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2.xml" ContentType="application/vnd.openxmlformats-officedocument.presentationml.notesSl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61" r:id="rId4"/>
    <p:sldId id="259" r:id="rId5"/>
    <p:sldId id="260" r:id="rId6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34615" autoAdjust="0"/>
    <p:restoredTop sz="94364" autoAdjust="0"/>
  </p:normalViewPr>
  <p:slideViewPr>
    <p:cSldViewPr>
      <p:cViewPr>
        <p:scale>
          <a:sx n="98" d="100"/>
          <a:sy n="98" d="100"/>
        </p:scale>
        <p:origin x="1740" y="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222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rene\Desktop\CISA\A.%20salmocida%20on%20B%20cells\Review%20Aeromonas\A.%20salmonicida%20on%20B%20cells%20(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rene\Desktop\CISA\A.%20salmocida%20on%20B%20cells\Review%20Aeromonas\A.%20salmonicida%20on%20B%20cells%20(1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rene\Desktop\CISA\A.%20salmocida%20on%20B%20cells\Review%20Aeromonas\A.%20salmonicida%20on%20B%20cells%20(1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rene\Desktop\CISA\A.%20salmocida%20on%20B%20cells\Review%20Aeromonas\A.%20salmonicida%20on%20B%20cells%20(1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rene\Desktop\CISA\A.%20salmocida%20on%20B%20cells\Review%20Aeromonas\A.%20salmonicida%20on%20B%20cells%20(1)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rene\Desktop\CISA\A.%20salmocida%20on%20B%20cells\Review%20Aeromonas\A.%20salmonicida%20on%20B%20cells%20(1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rene\Desktop\CISA\A.%20salmocida%20on%20B%20cells\Review%20Aeromonas\A.%20salmonicida%20on%20B%20cells%20(1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rene\Desktop\CISA\A.%20salmocida%20on%20B%20cells\Review%20Aeromonas\A.%20salmonicida%20on%20B%20cells%20(1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% linfos'!$B$10:$E$10</c:f>
                <c:numCache>
                  <c:formatCode>General</c:formatCode>
                  <c:ptCount val="4"/>
                  <c:pt idx="0">
                    <c:v>18.654413878298538</c:v>
                  </c:pt>
                  <c:pt idx="1">
                    <c:v>20.591702559179371</c:v>
                  </c:pt>
                  <c:pt idx="2">
                    <c:v>19.454902063123168</c:v>
                  </c:pt>
                  <c:pt idx="3">
                    <c:v>17.8033394406244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% linfos'!$B$1:$E$1</c:f>
              <c:strCache>
                <c:ptCount val="4"/>
                <c:pt idx="0">
                  <c:v>Control</c:v>
                </c:pt>
                <c:pt idx="1">
                  <c:v>A. salmonicida</c:v>
                </c:pt>
                <c:pt idx="2">
                  <c:v>Control peptide</c:v>
                </c:pt>
                <c:pt idx="3">
                  <c:v>MyD88 inhibitor</c:v>
                </c:pt>
              </c:strCache>
            </c:strRef>
          </c:cat>
          <c:val>
            <c:numRef>
              <c:f>'% linfos'!$B$9:$E$9</c:f>
              <c:numCache>
                <c:formatCode>General</c:formatCode>
                <c:ptCount val="4"/>
                <c:pt idx="0">
                  <c:v>29.972857142857144</c:v>
                </c:pt>
                <c:pt idx="1">
                  <c:v>32.978571428571428</c:v>
                </c:pt>
                <c:pt idx="2">
                  <c:v>30.978571428571428</c:v>
                </c:pt>
                <c:pt idx="3">
                  <c:v>26.3942857142857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8E2-407C-9F4C-4E4D91A42D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70480"/>
        <c:axId val="21270872"/>
      </c:barChart>
      <c:catAx>
        <c:axId val="21270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70872"/>
        <c:crosses val="autoZero"/>
        <c:auto val="1"/>
        <c:lblAlgn val="ctr"/>
        <c:lblOffset val="100"/>
        <c:noMultiLvlLbl val="0"/>
      </c:catAx>
      <c:valAx>
        <c:axId val="212708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alpha val="98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b="1">
                    <a:latin typeface="Arial" panose="020B0604020202020204" pitchFamily="34" charset="0"/>
                    <a:cs typeface="Arial" panose="020B0604020202020204" pitchFamily="34" charset="0"/>
                  </a:rPr>
                  <a:t>% Lymphocyte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alpha val="98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alpha val="98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70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>
              <a:alpha val="98000"/>
            </a:schemeClr>
          </a:solidFill>
        </a:defRPr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% linfos'!$B$10:$C$10,'% linfos'!$F$10:$G$10)</c:f>
                <c:numCache>
                  <c:formatCode>General</c:formatCode>
                  <c:ptCount val="4"/>
                  <c:pt idx="0">
                    <c:v>18.654413878298538</c:v>
                  </c:pt>
                  <c:pt idx="1">
                    <c:v>20.591702559179371</c:v>
                  </c:pt>
                  <c:pt idx="2">
                    <c:v>20.73362038539614</c:v>
                  </c:pt>
                  <c:pt idx="3">
                    <c:v>7.30329116938123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% linfos'!$B$1:$C$1,'% linfos'!$F$1:$G$1)</c:f>
              <c:strCache>
                <c:ptCount val="4"/>
                <c:pt idx="0">
                  <c:v>Control</c:v>
                </c:pt>
                <c:pt idx="1">
                  <c:v>A. salmonicida</c:v>
                </c:pt>
                <c:pt idx="2">
                  <c:v>DMSO </c:v>
                </c:pt>
                <c:pt idx="3">
                  <c:v>Resveratol </c:v>
                </c:pt>
              </c:strCache>
            </c:strRef>
          </c:cat>
          <c:val>
            <c:numRef>
              <c:f>('% linfos'!$B$9:$C$9,'% linfos'!$F$9:$G$9)</c:f>
              <c:numCache>
                <c:formatCode>General</c:formatCode>
                <c:ptCount val="4"/>
                <c:pt idx="0">
                  <c:v>29.972857142857144</c:v>
                </c:pt>
                <c:pt idx="1">
                  <c:v>32.978571428571428</c:v>
                </c:pt>
                <c:pt idx="2">
                  <c:v>30.401428571428571</c:v>
                </c:pt>
                <c:pt idx="3">
                  <c:v>12.9742857142857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9C9-4BCC-A204-938FE38C98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74792"/>
        <c:axId val="21273616"/>
      </c:barChart>
      <c:catAx>
        <c:axId val="21274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tx1">
                    <a:lumMod val="65000"/>
                    <a:lumOff val="35000"/>
                    <a:alpha val="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73616"/>
        <c:crosses val="autoZero"/>
        <c:auto val="1"/>
        <c:lblAlgn val="ctr"/>
        <c:lblOffset val="100"/>
        <c:noMultiLvlLbl val="0"/>
      </c:catAx>
      <c:valAx>
        <c:axId val="212736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ln>
                      <a:noFill/>
                    </a:ln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b="1">
                    <a:ln>
                      <a:noFill/>
                    </a:ln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 Lymphocyte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ln>
                    <a:noFill/>
                  </a:ln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747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04B-4D15-86DA-026D3C88E67F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04B-4D15-86DA-026D3C88E67F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04B-4D15-86DA-026D3C88E67F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004B-4D15-86DA-026D3C88E67F}"/>
              </c:ext>
            </c:extLst>
          </c:dPt>
          <c:errBars>
            <c:errBarType val="plus"/>
            <c:errValType val="cust"/>
            <c:noEndCap val="0"/>
            <c:plus>
              <c:numRef>
                <c:f>'n B cells'!$I$4:$L$4</c:f>
                <c:numCache>
                  <c:formatCode>General</c:formatCode>
                  <c:ptCount val="4"/>
                  <c:pt idx="0">
                    <c:v>556.65200722072063</c:v>
                  </c:pt>
                  <c:pt idx="1">
                    <c:v>1319.1939205439055</c:v>
                  </c:pt>
                  <c:pt idx="2">
                    <c:v>1214.2405875877541</c:v>
                  </c:pt>
                  <c:pt idx="3">
                    <c:v>853.031687926105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 B cells'!$I$2:$L$2</c:f>
              <c:strCache>
                <c:ptCount val="4"/>
                <c:pt idx="0">
                  <c:v>Control</c:v>
                </c:pt>
                <c:pt idx="1">
                  <c:v>Bacteria</c:v>
                </c:pt>
                <c:pt idx="2">
                  <c:v>peptide</c:v>
                </c:pt>
                <c:pt idx="3">
                  <c:v>MyD88 inh </c:v>
                </c:pt>
              </c:strCache>
            </c:strRef>
          </c:cat>
          <c:val>
            <c:numRef>
              <c:f>'n B cells'!$I$3:$L$3</c:f>
              <c:numCache>
                <c:formatCode>General</c:formatCode>
                <c:ptCount val="4"/>
                <c:pt idx="0">
                  <c:v>940.8</c:v>
                </c:pt>
                <c:pt idx="1">
                  <c:v>2306.8000000000002</c:v>
                </c:pt>
                <c:pt idx="2">
                  <c:v>2107.25</c:v>
                </c:pt>
                <c:pt idx="3">
                  <c:v>1245.8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004B-4D15-86DA-026D3C88E6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72048"/>
        <c:axId val="21272440"/>
      </c:barChart>
      <c:catAx>
        <c:axId val="21272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72440"/>
        <c:crosses val="autoZero"/>
        <c:auto val="1"/>
        <c:lblAlgn val="ctr"/>
        <c:lblOffset val="100"/>
        <c:noMultiLvlLbl val="0"/>
      </c:catAx>
      <c:valAx>
        <c:axId val="212724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b="1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umber</a:t>
                </a:r>
                <a:r>
                  <a:rPr lang="es-ES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of </a:t>
                </a:r>
                <a:r>
                  <a:rPr lang="es-ES" b="1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gM</a:t>
                </a:r>
                <a:r>
                  <a:rPr lang="es-ES" b="1" baseline="300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b="1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B </a:t>
                </a:r>
                <a:r>
                  <a:rPr lang="es-ES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r>
                  <a:rPr lang="es-ES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72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n B cells'!$N$4:$Q$4</c:f>
                <c:numCache>
                  <c:formatCode>General</c:formatCode>
                  <c:ptCount val="4"/>
                  <c:pt idx="0">
                    <c:v>556.65200722072063</c:v>
                  </c:pt>
                  <c:pt idx="1">
                    <c:v>1319.1939205439055</c:v>
                  </c:pt>
                  <c:pt idx="2">
                    <c:v>1397.0625026689524</c:v>
                  </c:pt>
                  <c:pt idx="3">
                    <c:v>1184.61658226182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 B cells'!$N$2:$Q$2</c:f>
              <c:strCache>
                <c:ptCount val="4"/>
                <c:pt idx="0">
                  <c:v>Control</c:v>
                </c:pt>
                <c:pt idx="1">
                  <c:v>Bacteria</c:v>
                </c:pt>
                <c:pt idx="2">
                  <c:v>DMSO </c:v>
                </c:pt>
                <c:pt idx="3">
                  <c:v>Resveratol </c:v>
                </c:pt>
              </c:strCache>
            </c:strRef>
          </c:cat>
          <c:val>
            <c:numRef>
              <c:f>'n B cells'!$N$3:$Q$3</c:f>
              <c:numCache>
                <c:formatCode>General</c:formatCode>
                <c:ptCount val="4"/>
                <c:pt idx="0">
                  <c:v>940.8</c:v>
                </c:pt>
                <c:pt idx="1">
                  <c:v>2306.8000000000002</c:v>
                </c:pt>
                <c:pt idx="2">
                  <c:v>2147</c:v>
                </c:pt>
                <c:pt idx="3">
                  <c:v>1621.41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766-4FC7-9025-720180063E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72832"/>
        <c:axId val="21268912"/>
      </c:barChart>
      <c:catAx>
        <c:axId val="21272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68912"/>
        <c:crosses val="autoZero"/>
        <c:auto val="1"/>
        <c:lblAlgn val="ctr"/>
        <c:lblOffset val="100"/>
        <c:noMultiLvlLbl val="0"/>
      </c:catAx>
      <c:valAx>
        <c:axId val="212689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1000" b="1" i="0" baseline="0" dirty="0" err="1" smtClean="0">
                    <a:effectLst/>
                  </a:rPr>
                  <a:t>Number</a:t>
                </a:r>
                <a:r>
                  <a:rPr lang="es-ES" sz="1000" b="1" i="0" baseline="0" dirty="0" smtClean="0">
                    <a:effectLst/>
                  </a:rPr>
                  <a:t> of </a:t>
                </a:r>
                <a:r>
                  <a:rPr lang="es-ES" sz="1000" b="1" i="0" baseline="0" dirty="0" err="1" smtClean="0">
                    <a:effectLst/>
                  </a:rPr>
                  <a:t>IgM</a:t>
                </a:r>
                <a:r>
                  <a:rPr lang="es-ES" sz="1000" b="1" i="0" baseline="30000" dirty="0" smtClean="0">
                    <a:effectLst/>
                  </a:rPr>
                  <a:t>+</a:t>
                </a:r>
                <a:r>
                  <a:rPr lang="es-ES" sz="1000" b="1" i="0" baseline="0" dirty="0" smtClean="0">
                    <a:effectLst/>
                  </a:rPr>
                  <a:t> B </a:t>
                </a:r>
                <a:r>
                  <a:rPr lang="es-ES" sz="1000" b="1" i="0" baseline="0" dirty="0" err="1" smtClean="0">
                    <a:effectLst/>
                  </a:rPr>
                  <a:t>cells</a:t>
                </a:r>
                <a:r>
                  <a:rPr lang="es-ES" sz="1000" b="1" i="0" baseline="0" dirty="0" smtClean="0">
                    <a:effectLst/>
                  </a:rPr>
                  <a:t> </a:t>
                </a:r>
                <a:endParaRPr lang="es-ES" sz="10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72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% B cells '!$AA$41:$AC$41</c:f>
                <c:numCache>
                  <c:formatCode>General</c:formatCode>
                  <c:ptCount val="3"/>
                  <c:pt idx="0">
                    <c:v>5.604420024366811</c:v>
                  </c:pt>
                  <c:pt idx="1">
                    <c:v>6.8548905031024212</c:v>
                  </c:pt>
                  <c:pt idx="2">
                    <c:v>6.54675492133316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% B cells '!$AA$32:$AC$32</c:f>
              <c:strCache>
                <c:ptCount val="3"/>
                <c:pt idx="0">
                  <c:v>Control</c:v>
                </c:pt>
                <c:pt idx="1">
                  <c:v>Control peptide</c:v>
                </c:pt>
                <c:pt idx="2">
                  <c:v>MyD88 inhibitor</c:v>
                </c:pt>
              </c:strCache>
            </c:strRef>
          </c:cat>
          <c:val>
            <c:numRef>
              <c:f>'% B cells '!$AA$40:$AC$40</c:f>
              <c:numCache>
                <c:formatCode>General</c:formatCode>
                <c:ptCount val="3"/>
                <c:pt idx="0">
                  <c:v>18.442857142857147</c:v>
                </c:pt>
                <c:pt idx="1">
                  <c:v>19.25714285714286</c:v>
                </c:pt>
                <c:pt idx="2">
                  <c:v>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C28-44BE-9E8D-F66853D1BA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75576"/>
        <c:axId val="21274008"/>
      </c:barChart>
      <c:catAx>
        <c:axId val="21275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94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1274008"/>
        <c:crosses val="autoZero"/>
        <c:auto val="1"/>
        <c:lblAlgn val="ctr"/>
        <c:lblOffset val="100"/>
        <c:noMultiLvlLbl val="0"/>
      </c:catAx>
      <c:valAx>
        <c:axId val="21274008"/>
        <c:scaling>
          <c:orientation val="minMax"/>
          <c:max val="3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r>
                  <a:rPr lang="es-ES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gM</a:t>
                </a:r>
                <a:r>
                  <a:rPr lang="es-ES" b="1" baseline="300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B cells</a:t>
                </a:r>
                <a:endParaRPr lang="es-ES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75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% B cells '!$AA$41,'% B cells '!$AD$41:$AE$41)</c:f>
                <c:numCache>
                  <c:formatCode>General</c:formatCode>
                  <c:ptCount val="3"/>
                  <c:pt idx="0">
                    <c:v>5.604420024366811</c:v>
                  </c:pt>
                  <c:pt idx="1">
                    <c:v>6.5224520659320264</c:v>
                  </c:pt>
                  <c:pt idx="2">
                    <c:v>7.67717706055080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% B cells '!$AA$32,'% B cells '!$AD$32:$AE$32)</c:f>
              <c:strCache>
                <c:ptCount val="3"/>
                <c:pt idx="0">
                  <c:v>Control</c:v>
                </c:pt>
                <c:pt idx="1">
                  <c:v>DMSO</c:v>
                </c:pt>
                <c:pt idx="2">
                  <c:v>Resveratrol</c:v>
                </c:pt>
              </c:strCache>
            </c:strRef>
          </c:cat>
          <c:val>
            <c:numRef>
              <c:f>('% B cells '!$AA$40,'% B cells '!$AD$40:$AE$40)</c:f>
              <c:numCache>
                <c:formatCode>General</c:formatCode>
                <c:ptCount val="3"/>
                <c:pt idx="0">
                  <c:v>18.442857142857147</c:v>
                </c:pt>
                <c:pt idx="1">
                  <c:v>20.87142857142857</c:v>
                </c:pt>
                <c:pt idx="2">
                  <c:v>24.0285714285714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729-4CB7-B237-5F250D5862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68520"/>
        <c:axId val="21269696"/>
      </c:barChart>
      <c:catAx>
        <c:axId val="21268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1269696"/>
        <c:crosses val="autoZero"/>
        <c:auto val="1"/>
        <c:lblAlgn val="ctr"/>
        <c:lblOffset val="100"/>
        <c:noMultiLvlLbl val="0"/>
      </c:catAx>
      <c:valAx>
        <c:axId val="2126969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r>
                  <a:rPr lang="es-ES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gM+ B cells</a:t>
                </a:r>
                <a:endParaRPr lang="es-ES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268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roliferation!$Z$26:$AB$26</c:f>
                <c:numCache>
                  <c:formatCode>General</c:formatCode>
                  <c:ptCount val="3"/>
                  <c:pt idx="0">
                    <c:v>8.3931916853284563E-2</c:v>
                  </c:pt>
                  <c:pt idx="1">
                    <c:v>4.2103048187354199E-2</c:v>
                  </c:pt>
                  <c:pt idx="2">
                    <c:v>5.734253802079802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roliferation!$Z$18:$AB$18</c:f>
              <c:strCache>
                <c:ptCount val="3"/>
                <c:pt idx="0">
                  <c:v>Control</c:v>
                </c:pt>
                <c:pt idx="1">
                  <c:v>Control peptide</c:v>
                </c:pt>
                <c:pt idx="2">
                  <c:v>MyD88 inhibitor</c:v>
                </c:pt>
              </c:strCache>
            </c:strRef>
          </c:cat>
          <c:val>
            <c:numRef>
              <c:f>proliferation!$Z$25:$AB$25</c:f>
              <c:numCache>
                <c:formatCode>General</c:formatCode>
                <c:ptCount val="3"/>
                <c:pt idx="0">
                  <c:v>0.10416666666666664</c:v>
                </c:pt>
                <c:pt idx="1">
                  <c:v>8.7333333333333318E-2</c:v>
                </c:pt>
                <c:pt idx="2">
                  <c:v>6.183333333333333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C7B-43AA-8A2B-1DDF5C5067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7727912"/>
        <c:axId val="317728304"/>
      </c:barChart>
      <c:catAx>
        <c:axId val="317727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30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317728304"/>
        <c:crosses val="autoZero"/>
        <c:auto val="1"/>
        <c:lblAlgn val="ctr"/>
        <c:lblOffset val="100"/>
        <c:noMultiLvlLbl val="0"/>
      </c:catAx>
      <c:valAx>
        <c:axId val="3177283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</a:t>
                </a:r>
                <a:r>
                  <a:rPr lang="es-ES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b="1" baseline="0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dU</a:t>
                </a:r>
                <a:r>
                  <a:rPr lang="es-ES" b="1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b="1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gM</a:t>
                </a:r>
                <a:r>
                  <a:rPr lang="es-ES" b="1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B </a:t>
                </a:r>
                <a:r>
                  <a:rPr lang="es-ES" b="1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es-E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317727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proliferation!$Z$26,proliferation!$AC$26:$AD$26)</c:f>
                <c:numCache>
                  <c:formatCode>General</c:formatCode>
                  <c:ptCount val="3"/>
                  <c:pt idx="0">
                    <c:v>8.3931916853284563E-2</c:v>
                  </c:pt>
                  <c:pt idx="1">
                    <c:v>5.0953573639801408E-2</c:v>
                  </c:pt>
                  <c:pt idx="2">
                    <c:v>2.643797773406027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proliferation!$Z$18,proliferation!$AC$18:$AD$18)</c:f>
              <c:strCache>
                <c:ptCount val="3"/>
                <c:pt idx="0">
                  <c:v>Control</c:v>
                </c:pt>
                <c:pt idx="1">
                  <c:v>DMSO </c:v>
                </c:pt>
                <c:pt idx="2">
                  <c:v>Resveratol </c:v>
                </c:pt>
              </c:strCache>
            </c:strRef>
          </c:cat>
          <c:val>
            <c:numRef>
              <c:f>(proliferation!$Z$25,proliferation!$AC$25:$AD$25)</c:f>
              <c:numCache>
                <c:formatCode>General</c:formatCode>
                <c:ptCount val="3"/>
                <c:pt idx="0">
                  <c:v>0.10416666666666664</c:v>
                </c:pt>
                <c:pt idx="1">
                  <c:v>6.6333333333333341E-2</c:v>
                </c:pt>
                <c:pt idx="2">
                  <c:v>2.6833333333333331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C52-40DE-BCFA-D57E10D786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7723992"/>
        <c:axId val="317724384"/>
      </c:barChart>
      <c:catAx>
        <c:axId val="317723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317724384"/>
        <c:crosses val="autoZero"/>
        <c:auto val="1"/>
        <c:lblAlgn val="ctr"/>
        <c:lblOffset val="100"/>
        <c:noMultiLvlLbl val="0"/>
      </c:catAx>
      <c:valAx>
        <c:axId val="3177243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 </a:t>
                </a:r>
                <a:r>
                  <a:rPr lang="es-ES" b="1" dirty="0" err="1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dU</a:t>
                </a:r>
                <a:r>
                  <a:rPr lang="es-ES" b="1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gM</a:t>
                </a:r>
                <a:r>
                  <a:rPr lang="es-ES" b="1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s-ES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B </a:t>
                </a:r>
                <a:r>
                  <a:rPr lang="es-ES" b="1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es-ES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317723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1A6E79-8DF3-4D32-8C21-7FA33C867982}" type="datetimeFigureOut">
              <a:rPr lang="en-US" smtClean="0"/>
              <a:t>4/27/2020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6263CF-6018-4318-B128-6A210C3AA62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83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6263CF-6018-4318-B128-6A210C3AA62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8158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6263CF-6018-4318-B128-6A210C3AA62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403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73160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7564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4997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1807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49595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8722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3633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5021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9322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9277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3183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10D64-447E-4FFD-869F-00E9DB12E07B}" type="datetimeFigureOut">
              <a:rPr lang="es-ES" smtClean="0"/>
              <a:t>27/04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F1CDAD-E8BB-4E43-A16F-1D2644A96A3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1357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ángulo 2"/>
          <p:cNvSpPr/>
          <p:nvPr/>
        </p:nvSpPr>
        <p:spPr>
          <a:xfrm>
            <a:off x="548680" y="1187624"/>
            <a:ext cx="5544616" cy="49675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2000" b="1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eromonas</a:t>
            </a:r>
            <a:r>
              <a:rPr lang="en-GB" sz="20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2000" b="1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lmonicida</a:t>
            </a:r>
            <a:r>
              <a:rPr lang="en-GB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ctivates rainbow trout </a:t>
            </a:r>
            <a:r>
              <a:rPr lang="en-GB" sz="2000" b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gM</a:t>
            </a:r>
            <a:r>
              <a:rPr lang="en-GB" sz="2000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20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 cells signalling through Toll like receptors</a:t>
            </a:r>
            <a:endParaRPr lang="es-ES" sz="20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n-GB" dirty="0" smtClean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s-ES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E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ene </a:t>
            </a:r>
            <a:r>
              <a:rPr lang="es-E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leto</a:t>
            </a:r>
            <a:r>
              <a:rPr lang="es-E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sther Morel, Estefanía Muñoz-</a:t>
            </a:r>
            <a:r>
              <a:rPr lang="es-ES" sz="16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ienza</a:t>
            </a:r>
            <a:r>
              <a:rPr lang="es-E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atricia Díaz-Rosales, Carolina </a:t>
            </a:r>
            <a:r>
              <a:rPr lang="es-ES" sz="16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falla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sh Immunology and Pathology Laboratory,</a:t>
            </a:r>
            <a:r>
              <a:rPr lang="en-GB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mal Health Research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nter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ISA-INIA), </a:t>
            </a:r>
            <a:r>
              <a:rPr lang="en-GB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deolmos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drid, Spain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n-GB" sz="16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INFORMATION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67287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Imagen 8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556"/>
          <a:stretch/>
        </p:blipFill>
        <p:spPr>
          <a:xfrm>
            <a:off x="344552" y="351350"/>
            <a:ext cx="4406287" cy="6612923"/>
          </a:xfrm>
          <a:prstGeom prst="rect">
            <a:avLst/>
          </a:prstGeom>
        </p:spPr>
      </p:pic>
      <p:grpSp>
        <p:nvGrpSpPr>
          <p:cNvPr id="37" name="Grupo 36"/>
          <p:cNvGrpSpPr/>
          <p:nvPr/>
        </p:nvGrpSpPr>
        <p:grpSpPr>
          <a:xfrm>
            <a:off x="237846" y="-206162"/>
            <a:ext cx="2018411" cy="7350055"/>
            <a:chOff x="237845" y="-383578"/>
            <a:chExt cx="2018411" cy="7962560"/>
          </a:xfrm>
        </p:grpSpPr>
        <p:cxnSp>
          <p:nvCxnSpPr>
            <p:cNvPr id="3" name="Conector recto de flecha 2"/>
            <p:cNvCxnSpPr/>
            <p:nvPr/>
          </p:nvCxnSpPr>
          <p:spPr>
            <a:xfrm flipV="1">
              <a:off x="357161" y="775058"/>
              <a:ext cx="0" cy="666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CuadroTexto 30"/>
            <p:cNvSpPr txBox="1"/>
            <p:nvPr/>
          </p:nvSpPr>
          <p:spPr>
            <a:xfrm rot="16200000">
              <a:off x="-249824" y="104091"/>
              <a:ext cx="12061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1050086" y="7328914"/>
              <a:ext cx="1206170" cy="250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Conector recto de flecha 35"/>
            <p:cNvCxnSpPr/>
            <p:nvPr/>
          </p:nvCxnSpPr>
          <p:spPr>
            <a:xfrm>
              <a:off x="352918" y="7436220"/>
              <a:ext cx="73863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CuadroTexto 52"/>
          <p:cNvSpPr txBox="1"/>
          <p:nvPr/>
        </p:nvSpPr>
        <p:spPr>
          <a:xfrm>
            <a:off x="553266" y="465252"/>
            <a:ext cx="7864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uadroTexto 53"/>
          <p:cNvSpPr txBox="1"/>
          <p:nvPr/>
        </p:nvSpPr>
        <p:spPr>
          <a:xfrm>
            <a:off x="553266" y="1557192"/>
            <a:ext cx="10657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s-ES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lmonicida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uadroTexto 54"/>
          <p:cNvSpPr txBox="1"/>
          <p:nvPr/>
        </p:nvSpPr>
        <p:spPr>
          <a:xfrm>
            <a:off x="535848" y="2771800"/>
            <a:ext cx="1083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s-E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ptide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uadroTexto 55"/>
          <p:cNvSpPr txBox="1"/>
          <p:nvPr/>
        </p:nvSpPr>
        <p:spPr>
          <a:xfrm>
            <a:off x="544557" y="3909699"/>
            <a:ext cx="1083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yD88 </a:t>
            </a:r>
            <a:r>
              <a:rPr lang="es-E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hibitor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uadroTexto 56"/>
          <p:cNvSpPr txBox="1"/>
          <p:nvPr/>
        </p:nvSpPr>
        <p:spPr>
          <a:xfrm>
            <a:off x="553266" y="5004628"/>
            <a:ext cx="1083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CuadroTexto 57"/>
          <p:cNvSpPr txBox="1"/>
          <p:nvPr/>
        </p:nvSpPr>
        <p:spPr>
          <a:xfrm>
            <a:off x="553266" y="6084748"/>
            <a:ext cx="10831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veratrol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CuadroTexto 58"/>
          <p:cNvSpPr txBox="1"/>
          <p:nvPr/>
        </p:nvSpPr>
        <p:spPr>
          <a:xfrm>
            <a:off x="1153331" y="1161135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1.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CuadroTexto 62"/>
          <p:cNvSpPr txBox="1"/>
          <p:nvPr/>
        </p:nvSpPr>
        <p:spPr>
          <a:xfrm>
            <a:off x="1153331" y="2259470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.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CuadroTexto 66"/>
          <p:cNvSpPr txBox="1"/>
          <p:nvPr/>
        </p:nvSpPr>
        <p:spPr>
          <a:xfrm>
            <a:off x="1153331" y="3355839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6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CuadroTexto 70"/>
          <p:cNvSpPr txBox="1"/>
          <p:nvPr/>
        </p:nvSpPr>
        <p:spPr>
          <a:xfrm>
            <a:off x="1153331" y="4452208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7.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CuadroTexto 74"/>
          <p:cNvSpPr txBox="1"/>
          <p:nvPr/>
        </p:nvSpPr>
        <p:spPr>
          <a:xfrm>
            <a:off x="1153331" y="5548577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.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CuadroTexto 78"/>
          <p:cNvSpPr txBox="1"/>
          <p:nvPr/>
        </p:nvSpPr>
        <p:spPr>
          <a:xfrm>
            <a:off x="1153331" y="6646736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4.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6" name="Grupo 85"/>
          <p:cNvGrpSpPr/>
          <p:nvPr/>
        </p:nvGrpSpPr>
        <p:grpSpPr>
          <a:xfrm>
            <a:off x="1636399" y="-205201"/>
            <a:ext cx="2018411" cy="7350055"/>
            <a:chOff x="237845" y="-383578"/>
            <a:chExt cx="2018411" cy="7962560"/>
          </a:xfrm>
        </p:grpSpPr>
        <p:cxnSp>
          <p:nvCxnSpPr>
            <p:cNvPr id="87" name="Conector recto de flecha 86"/>
            <p:cNvCxnSpPr/>
            <p:nvPr/>
          </p:nvCxnSpPr>
          <p:spPr>
            <a:xfrm flipV="1">
              <a:off x="357161" y="775058"/>
              <a:ext cx="0" cy="666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CuadroTexto 87"/>
            <p:cNvSpPr txBox="1"/>
            <p:nvPr/>
          </p:nvSpPr>
          <p:spPr>
            <a:xfrm rot="16200000">
              <a:off x="-249824" y="104091"/>
              <a:ext cx="12061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CuadroTexto 88"/>
            <p:cNvSpPr txBox="1"/>
            <p:nvPr/>
          </p:nvSpPr>
          <p:spPr>
            <a:xfrm>
              <a:off x="1050086" y="7328914"/>
              <a:ext cx="1206170" cy="250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Conector recto de flecha 89"/>
            <p:cNvCxnSpPr/>
            <p:nvPr/>
          </p:nvCxnSpPr>
          <p:spPr>
            <a:xfrm>
              <a:off x="352918" y="7436220"/>
              <a:ext cx="73863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Grupo 90"/>
          <p:cNvGrpSpPr/>
          <p:nvPr/>
        </p:nvGrpSpPr>
        <p:grpSpPr>
          <a:xfrm>
            <a:off x="3226581" y="-206162"/>
            <a:ext cx="2018411" cy="7350055"/>
            <a:chOff x="237845" y="-383578"/>
            <a:chExt cx="2018411" cy="7962560"/>
          </a:xfrm>
        </p:grpSpPr>
        <p:cxnSp>
          <p:nvCxnSpPr>
            <p:cNvPr id="92" name="Conector recto de flecha 91"/>
            <p:cNvCxnSpPr/>
            <p:nvPr/>
          </p:nvCxnSpPr>
          <p:spPr>
            <a:xfrm flipV="1">
              <a:off x="357161" y="775058"/>
              <a:ext cx="0" cy="666000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CuadroTexto 92"/>
            <p:cNvSpPr txBox="1"/>
            <p:nvPr/>
          </p:nvSpPr>
          <p:spPr>
            <a:xfrm rot="16200000">
              <a:off x="-249824" y="104091"/>
              <a:ext cx="12061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CuadroTexto 93"/>
            <p:cNvSpPr txBox="1"/>
            <p:nvPr/>
          </p:nvSpPr>
          <p:spPr>
            <a:xfrm>
              <a:off x="1050086" y="7328914"/>
              <a:ext cx="1206170" cy="2500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-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Conector recto de flecha 94"/>
            <p:cNvCxnSpPr/>
            <p:nvPr/>
          </p:nvCxnSpPr>
          <p:spPr>
            <a:xfrm>
              <a:off x="352918" y="7436220"/>
              <a:ext cx="73863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1" name="CuadroTexto 100"/>
          <p:cNvSpPr txBox="1"/>
          <p:nvPr/>
        </p:nvSpPr>
        <p:spPr>
          <a:xfrm>
            <a:off x="2545081" y="1161135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.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CuadroTexto 101"/>
          <p:cNvSpPr txBox="1"/>
          <p:nvPr/>
        </p:nvSpPr>
        <p:spPr>
          <a:xfrm>
            <a:off x="4123042" y="1161135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.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CuadroTexto 103"/>
          <p:cNvSpPr txBox="1"/>
          <p:nvPr/>
        </p:nvSpPr>
        <p:spPr>
          <a:xfrm>
            <a:off x="2545081" y="2259470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9.9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CuadroTexto 104"/>
          <p:cNvSpPr txBox="1"/>
          <p:nvPr/>
        </p:nvSpPr>
        <p:spPr>
          <a:xfrm>
            <a:off x="4123042" y="2259470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2.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CuadroTexto 106"/>
          <p:cNvSpPr txBox="1"/>
          <p:nvPr/>
        </p:nvSpPr>
        <p:spPr>
          <a:xfrm>
            <a:off x="2545081" y="3355839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6.9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CuadroTexto 107"/>
          <p:cNvSpPr txBox="1"/>
          <p:nvPr/>
        </p:nvSpPr>
        <p:spPr>
          <a:xfrm>
            <a:off x="4123042" y="3355839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1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CuadroTexto 109"/>
          <p:cNvSpPr txBox="1"/>
          <p:nvPr/>
        </p:nvSpPr>
        <p:spPr>
          <a:xfrm>
            <a:off x="2545081" y="4452208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3.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CuadroTexto 110"/>
          <p:cNvSpPr txBox="1"/>
          <p:nvPr/>
        </p:nvSpPr>
        <p:spPr>
          <a:xfrm>
            <a:off x="4123042" y="4452208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4.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CuadroTexto 112"/>
          <p:cNvSpPr txBox="1"/>
          <p:nvPr/>
        </p:nvSpPr>
        <p:spPr>
          <a:xfrm>
            <a:off x="2545081" y="5548577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5.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CuadroTexto 113"/>
          <p:cNvSpPr txBox="1"/>
          <p:nvPr/>
        </p:nvSpPr>
        <p:spPr>
          <a:xfrm>
            <a:off x="4123042" y="5548577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2.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CuadroTexto 115"/>
          <p:cNvSpPr txBox="1"/>
          <p:nvPr/>
        </p:nvSpPr>
        <p:spPr>
          <a:xfrm>
            <a:off x="2545081" y="6646736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8.3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CuadroTexto 116"/>
          <p:cNvSpPr txBox="1"/>
          <p:nvPr/>
        </p:nvSpPr>
        <p:spPr>
          <a:xfrm>
            <a:off x="4123042" y="6646736"/>
            <a:ext cx="627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2.6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1 CuadroTexto"/>
          <p:cNvSpPr txBox="1"/>
          <p:nvPr/>
        </p:nvSpPr>
        <p:spPr>
          <a:xfrm>
            <a:off x="295057" y="7355398"/>
            <a:ext cx="582623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ting strategy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lenic leukocytes were incubated with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yD88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hibitor peptide (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M), the control peptide (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M), resveratrol (50 µM), the same volume of DMSO or media alone f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reafter, cells were incubated with 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monicida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atio 1:2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3 days. Controls with media alone wer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o included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sample, FSC/SSC profiles including a defined gate for lymphoid cells are shown (left panel). FSC-H/FSC-A profiles within the lymphoid gate indicate singlets. DAPI negative cells within singlet gate were gated in order to select aliv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in all conditions. (b) Mean percentage of cells within the lymphoid gat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ean+ SD; n=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)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59 CuadroTexto"/>
          <p:cNvSpPr txBox="1"/>
          <p:nvPr/>
        </p:nvSpPr>
        <p:spPr>
          <a:xfrm>
            <a:off x="-20093" y="0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Fig. S1</a:t>
            </a:r>
            <a:endParaRPr lang="es-ES" sz="1200" b="1" dirty="0"/>
          </a:p>
        </p:txBody>
      </p:sp>
      <p:grpSp>
        <p:nvGrpSpPr>
          <p:cNvPr id="5" name="Grupo 4"/>
          <p:cNvGrpSpPr/>
          <p:nvPr/>
        </p:nvGrpSpPr>
        <p:grpSpPr>
          <a:xfrm>
            <a:off x="4688410" y="1195971"/>
            <a:ext cx="1790560" cy="2570063"/>
            <a:chOff x="4688410" y="1195971"/>
            <a:chExt cx="1790560" cy="2570063"/>
          </a:xfrm>
        </p:grpSpPr>
        <p:grpSp>
          <p:nvGrpSpPr>
            <p:cNvPr id="50" name="Grupo 49"/>
            <p:cNvGrpSpPr/>
            <p:nvPr/>
          </p:nvGrpSpPr>
          <p:grpSpPr>
            <a:xfrm>
              <a:off x="4688410" y="3181259"/>
              <a:ext cx="1688309" cy="584775"/>
              <a:chOff x="64052" y="6178557"/>
              <a:chExt cx="1688309" cy="584775"/>
            </a:xfrm>
          </p:grpSpPr>
          <p:sp>
            <p:nvSpPr>
              <p:cNvPr id="51" name="CuadroTexto 50"/>
              <p:cNvSpPr txBox="1"/>
              <p:nvPr/>
            </p:nvSpPr>
            <p:spPr>
              <a:xfrm>
                <a:off x="950343" y="6178557"/>
                <a:ext cx="25171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CuadroTexto 51"/>
              <p:cNvSpPr txBox="1"/>
              <p:nvPr/>
            </p:nvSpPr>
            <p:spPr>
              <a:xfrm>
                <a:off x="64052" y="6190579"/>
                <a:ext cx="113211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. </a:t>
                </a:r>
                <a:r>
                  <a:rPr lang="es-ES" sz="800" b="1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monicida</a:t>
                </a:r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</a:p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rol </a:t>
                </a:r>
                <a:r>
                  <a:rPr lang="es-ES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s-ES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ptide</a:t>
                </a:r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	          </a:t>
                </a:r>
              </a:p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yD88 </a:t>
                </a:r>
                <a:r>
                  <a:rPr lang="es-ES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nhibitor</a:t>
                </a:r>
                <a:r>
                  <a:rPr lang="es-E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CuadroTexto 60"/>
              <p:cNvSpPr txBox="1"/>
              <p:nvPr/>
            </p:nvSpPr>
            <p:spPr>
              <a:xfrm>
                <a:off x="1126835" y="6178557"/>
                <a:ext cx="223501" cy="4648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CuadroTexto 61"/>
              <p:cNvSpPr txBox="1"/>
              <p:nvPr/>
            </p:nvSpPr>
            <p:spPr>
              <a:xfrm>
                <a:off x="1308743" y="6178557"/>
                <a:ext cx="25171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CuadroTexto 63"/>
              <p:cNvSpPr txBox="1"/>
              <p:nvPr/>
            </p:nvSpPr>
            <p:spPr>
              <a:xfrm>
                <a:off x="1500646" y="6178557"/>
                <a:ext cx="25171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65" name="Gráfico 6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81316923"/>
                </p:ext>
              </p:extLst>
            </p:nvPr>
          </p:nvGraphicFramePr>
          <p:xfrm>
            <a:off x="5038970" y="1195971"/>
            <a:ext cx="144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grpSp>
        <p:nvGrpSpPr>
          <p:cNvPr id="4" name="Grupo 3"/>
          <p:cNvGrpSpPr/>
          <p:nvPr/>
        </p:nvGrpSpPr>
        <p:grpSpPr>
          <a:xfrm>
            <a:off x="4793849" y="3924403"/>
            <a:ext cx="1766630" cy="2601480"/>
            <a:chOff x="4793849" y="3924403"/>
            <a:chExt cx="1766630" cy="2601480"/>
          </a:xfrm>
        </p:grpSpPr>
        <p:grpSp>
          <p:nvGrpSpPr>
            <p:cNvPr id="66" name="Grupo 65"/>
            <p:cNvGrpSpPr/>
            <p:nvPr/>
          </p:nvGrpSpPr>
          <p:grpSpPr>
            <a:xfrm>
              <a:off x="4793849" y="5941108"/>
              <a:ext cx="1668001" cy="584775"/>
              <a:chOff x="5589845" y="2593431"/>
              <a:chExt cx="1668001" cy="584775"/>
            </a:xfrm>
          </p:grpSpPr>
          <p:sp>
            <p:nvSpPr>
              <p:cNvPr id="68" name="CuadroTexto 67"/>
              <p:cNvSpPr txBox="1"/>
              <p:nvPr/>
            </p:nvSpPr>
            <p:spPr>
              <a:xfrm>
                <a:off x="5589845" y="2605453"/>
                <a:ext cx="113211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. </a:t>
                </a:r>
                <a:r>
                  <a:rPr lang="es-ES" sz="800" b="1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monicida</a:t>
                </a:r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</a:p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MSO	          </a:t>
                </a:r>
              </a:p>
              <a:p>
                <a:r>
                  <a:rPr lang="es-ES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Resveratrol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CuadroTexto 68"/>
              <p:cNvSpPr txBox="1"/>
              <p:nvPr/>
            </p:nvSpPr>
            <p:spPr>
              <a:xfrm>
                <a:off x="6642075" y="2593431"/>
                <a:ext cx="223501" cy="4648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CuadroTexto 69"/>
              <p:cNvSpPr txBox="1"/>
              <p:nvPr/>
            </p:nvSpPr>
            <p:spPr>
              <a:xfrm>
                <a:off x="6822030" y="2593431"/>
                <a:ext cx="25171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CuadroTexto 71"/>
              <p:cNvSpPr txBox="1"/>
              <p:nvPr/>
            </p:nvSpPr>
            <p:spPr>
              <a:xfrm>
                <a:off x="7006131" y="2593431"/>
                <a:ext cx="25171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CuadroTexto 72"/>
              <p:cNvSpPr txBox="1"/>
              <p:nvPr/>
            </p:nvSpPr>
            <p:spPr>
              <a:xfrm>
                <a:off x="6466809" y="2593431"/>
                <a:ext cx="25171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s-ES" sz="800" b="1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74" name="Gráfico 7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48723479"/>
                </p:ext>
              </p:extLst>
            </p:nvPr>
          </p:nvGraphicFramePr>
          <p:xfrm>
            <a:off x="5120479" y="3924403"/>
            <a:ext cx="1440000" cy="216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76" name="CuadroTexto 75"/>
          <p:cNvSpPr txBox="1"/>
          <p:nvPr/>
        </p:nvSpPr>
        <p:spPr>
          <a:xfrm>
            <a:off x="553266" y="2660532"/>
            <a:ext cx="10657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s-ES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lmonicida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CuadroTexto 76"/>
          <p:cNvSpPr txBox="1"/>
          <p:nvPr/>
        </p:nvSpPr>
        <p:spPr>
          <a:xfrm>
            <a:off x="553266" y="3767265"/>
            <a:ext cx="10657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s-ES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lmonicida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CuadroTexto 77"/>
          <p:cNvSpPr txBox="1"/>
          <p:nvPr/>
        </p:nvSpPr>
        <p:spPr>
          <a:xfrm>
            <a:off x="562233" y="4861542"/>
            <a:ext cx="10657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s-ES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lmonicida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CuadroTexto 79"/>
          <p:cNvSpPr txBox="1"/>
          <p:nvPr/>
        </p:nvSpPr>
        <p:spPr>
          <a:xfrm>
            <a:off x="548893" y="5959484"/>
            <a:ext cx="10657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s-ES" sz="8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lmonicida</a:t>
            </a:r>
            <a:endParaRPr lang="en-U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4728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2257685"/>
              </p:ext>
            </p:extLst>
          </p:nvPr>
        </p:nvGraphicFramePr>
        <p:xfrm>
          <a:off x="1214663" y="1129391"/>
          <a:ext cx="14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áfico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5485421"/>
              </p:ext>
            </p:extLst>
          </p:nvPr>
        </p:nvGraphicFramePr>
        <p:xfrm>
          <a:off x="3418034" y="1129392"/>
          <a:ext cx="144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6" name="Grupo 5"/>
          <p:cNvGrpSpPr/>
          <p:nvPr/>
        </p:nvGrpSpPr>
        <p:grpSpPr>
          <a:xfrm>
            <a:off x="966354" y="3154091"/>
            <a:ext cx="1599597" cy="584775"/>
            <a:chOff x="64052" y="6178557"/>
            <a:chExt cx="1599597" cy="584775"/>
          </a:xfrm>
        </p:grpSpPr>
        <p:sp>
          <p:nvSpPr>
            <p:cNvPr id="7" name="CuadroTexto 6"/>
            <p:cNvSpPr txBox="1"/>
            <p:nvPr/>
          </p:nvSpPr>
          <p:spPr>
            <a:xfrm>
              <a:off x="950343" y="6178557"/>
              <a:ext cx="25171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64052" y="6190579"/>
              <a:ext cx="113211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</a:t>
              </a:r>
              <a:r>
                <a:rPr lang="es-ES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almonicida</a:t>
              </a:r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</a:p>
            <a:p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  <a:r>
                <a:rPr lang="es-E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s-E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ptide</a:t>
              </a:r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	          </a:t>
              </a:r>
            </a:p>
            <a:p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D88 </a:t>
              </a:r>
              <a:r>
                <a:rPr lang="es-E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r>
                <a:rPr lang="es-E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1099539" y="6178557"/>
              <a:ext cx="223501" cy="464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1254151" y="6178557"/>
              <a:ext cx="25171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CuadroTexto 10"/>
            <p:cNvSpPr txBox="1"/>
            <p:nvPr/>
          </p:nvSpPr>
          <p:spPr>
            <a:xfrm>
              <a:off x="1411934" y="6178557"/>
              <a:ext cx="25171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Grupo 11"/>
          <p:cNvGrpSpPr/>
          <p:nvPr/>
        </p:nvGrpSpPr>
        <p:grpSpPr>
          <a:xfrm>
            <a:off x="3190033" y="3154091"/>
            <a:ext cx="1579289" cy="584775"/>
            <a:chOff x="5589845" y="2593431"/>
            <a:chExt cx="1579289" cy="584775"/>
          </a:xfrm>
        </p:grpSpPr>
        <p:sp>
          <p:nvSpPr>
            <p:cNvPr id="13" name="CuadroTexto 12"/>
            <p:cNvSpPr txBox="1"/>
            <p:nvPr/>
          </p:nvSpPr>
          <p:spPr>
            <a:xfrm>
              <a:off x="5589845" y="2605453"/>
              <a:ext cx="113211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</a:t>
              </a:r>
              <a:r>
                <a:rPr lang="es-ES" sz="800" b="1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almonicida</a:t>
              </a:r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</a:p>
            <a:p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	          </a:t>
              </a:r>
            </a:p>
            <a:p>
              <a:r>
                <a:rPr lang="es-E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esveratrol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CuadroTexto 13"/>
            <p:cNvSpPr txBox="1"/>
            <p:nvPr/>
          </p:nvSpPr>
          <p:spPr>
            <a:xfrm>
              <a:off x="6621603" y="2593431"/>
              <a:ext cx="223501" cy="4648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CuadroTexto 14"/>
            <p:cNvSpPr txBox="1"/>
            <p:nvPr/>
          </p:nvSpPr>
          <p:spPr>
            <a:xfrm>
              <a:off x="6760614" y="2593431"/>
              <a:ext cx="25171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CuadroTexto 15"/>
            <p:cNvSpPr txBox="1"/>
            <p:nvPr/>
          </p:nvSpPr>
          <p:spPr>
            <a:xfrm>
              <a:off x="6917419" y="2593431"/>
              <a:ext cx="25171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6466809" y="2593431"/>
              <a:ext cx="25171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s-ES" sz="800" b="1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s-ES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  <a:p>
              <a:r>
                <a:rPr lang="es-E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8" name="Conector recto 17"/>
          <p:cNvCxnSpPr/>
          <p:nvPr/>
        </p:nvCxnSpPr>
        <p:spPr>
          <a:xfrm>
            <a:off x="1969987" y="1408127"/>
            <a:ext cx="16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CuadroTexto 18"/>
          <p:cNvSpPr txBox="1"/>
          <p:nvPr/>
        </p:nvSpPr>
        <p:spPr>
          <a:xfrm>
            <a:off x="1854331" y="1225064"/>
            <a:ext cx="399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Conector recto 19"/>
          <p:cNvCxnSpPr/>
          <p:nvPr/>
        </p:nvCxnSpPr>
        <p:spPr>
          <a:xfrm>
            <a:off x="1969987" y="1276068"/>
            <a:ext cx="32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CuadroTexto 20"/>
          <p:cNvSpPr txBox="1"/>
          <p:nvPr/>
        </p:nvSpPr>
        <p:spPr>
          <a:xfrm>
            <a:off x="1935826" y="1101950"/>
            <a:ext cx="399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Conector recto 21"/>
          <p:cNvCxnSpPr/>
          <p:nvPr/>
        </p:nvCxnSpPr>
        <p:spPr>
          <a:xfrm>
            <a:off x="2284821" y="1517488"/>
            <a:ext cx="16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CuadroTexto 22"/>
          <p:cNvSpPr txBox="1"/>
          <p:nvPr/>
        </p:nvSpPr>
        <p:spPr>
          <a:xfrm>
            <a:off x="2169165" y="1334425"/>
            <a:ext cx="399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Conector recto 23"/>
          <p:cNvCxnSpPr/>
          <p:nvPr/>
        </p:nvCxnSpPr>
        <p:spPr>
          <a:xfrm>
            <a:off x="4167707" y="1389923"/>
            <a:ext cx="16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CuadroTexto 24"/>
          <p:cNvSpPr txBox="1"/>
          <p:nvPr/>
        </p:nvSpPr>
        <p:spPr>
          <a:xfrm>
            <a:off x="4052051" y="1206860"/>
            <a:ext cx="399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Conector recto 25"/>
          <p:cNvCxnSpPr/>
          <p:nvPr/>
        </p:nvCxnSpPr>
        <p:spPr>
          <a:xfrm>
            <a:off x="4167707" y="1257864"/>
            <a:ext cx="32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CuadroTexto 26"/>
          <p:cNvSpPr txBox="1"/>
          <p:nvPr/>
        </p:nvSpPr>
        <p:spPr>
          <a:xfrm>
            <a:off x="4133546" y="1059536"/>
            <a:ext cx="399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59 CuadroTexto"/>
          <p:cNvSpPr txBox="1"/>
          <p:nvPr/>
        </p:nvSpPr>
        <p:spPr>
          <a:xfrm>
            <a:off x="0" y="23869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Fig. S2 </a:t>
            </a:r>
            <a:endParaRPr lang="es-ES" sz="1200" b="1" dirty="0"/>
          </a:p>
        </p:txBody>
      </p:sp>
      <p:cxnSp>
        <p:nvCxnSpPr>
          <p:cNvPr id="31" name="Conector recto 30"/>
          <p:cNvCxnSpPr/>
          <p:nvPr/>
        </p:nvCxnSpPr>
        <p:spPr>
          <a:xfrm flipV="1">
            <a:off x="2119039" y="1106905"/>
            <a:ext cx="347435" cy="871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CuadroTexto 31"/>
          <p:cNvSpPr txBox="1"/>
          <p:nvPr/>
        </p:nvSpPr>
        <p:spPr>
          <a:xfrm>
            <a:off x="1985048" y="939240"/>
            <a:ext cx="5990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1 CuadroTexto"/>
          <p:cNvSpPr txBox="1"/>
          <p:nvPr/>
        </p:nvSpPr>
        <p:spPr>
          <a:xfrm>
            <a:off x="308808" y="4393819"/>
            <a:ext cx="582623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</a:t>
            </a:r>
            <a:r>
              <a:rPr lang="en-GB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monicida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th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number of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in cultures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lenic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ukocytes were incubated with MyD88 inhibitor peptide (100 µM), the control peptide (100 µM), resveratrol (50 µM), the same volume of DMSO or media alone for 1 h. Thereafter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incubated with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lmonicida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belled with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to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C Green. Controls without bacteria were also included.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days of incubation at 20ºC, cells were labelled with anti-trout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PC and th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number of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i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ed by flow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+ SD;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11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CuadroTexto 33"/>
          <p:cNvSpPr txBox="1"/>
          <p:nvPr/>
        </p:nvSpPr>
        <p:spPr>
          <a:xfrm>
            <a:off x="1985317" y="939240"/>
            <a:ext cx="5990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01365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59 CuadroTexto"/>
          <p:cNvSpPr txBox="1"/>
          <p:nvPr/>
        </p:nvSpPr>
        <p:spPr>
          <a:xfrm>
            <a:off x="9519" y="0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Fig. S3 </a:t>
            </a:r>
            <a:endParaRPr lang="es-ES" sz="1200" b="1" dirty="0"/>
          </a:p>
        </p:txBody>
      </p:sp>
      <p:sp>
        <p:nvSpPr>
          <p:cNvPr id="103" name="CuadroTexto 102"/>
          <p:cNvSpPr txBox="1"/>
          <p:nvPr/>
        </p:nvSpPr>
        <p:spPr>
          <a:xfrm>
            <a:off x="281893" y="582746"/>
            <a:ext cx="419643" cy="3789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CuadroTexto 103"/>
          <p:cNvSpPr txBox="1"/>
          <p:nvPr/>
        </p:nvSpPr>
        <p:spPr>
          <a:xfrm>
            <a:off x="1671706" y="582746"/>
            <a:ext cx="419643" cy="3789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8" name="Gráfico 9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6594390"/>
              </p:ext>
            </p:extLst>
          </p:nvPr>
        </p:nvGraphicFramePr>
        <p:xfrm>
          <a:off x="281893" y="854366"/>
          <a:ext cx="14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1" name="Gráfico 10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7505892"/>
              </p:ext>
            </p:extLst>
          </p:nvPr>
        </p:nvGraphicFramePr>
        <p:xfrm>
          <a:off x="281893" y="3379073"/>
          <a:ext cx="14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6" name="Gráfico 10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38032692"/>
              </p:ext>
            </p:extLst>
          </p:nvPr>
        </p:nvGraphicFramePr>
        <p:xfrm>
          <a:off x="1779567" y="854366"/>
          <a:ext cx="14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7" name="Gráfico 10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5560200"/>
              </p:ext>
            </p:extLst>
          </p:nvPr>
        </p:nvGraphicFramePr>
        <p:xfrm>
          <a:off x="1779567" y="3379073"/>
          <a:ext cx="1440000" cy="25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7" name="1 CuadroTexto"/>
          <p:cNvSpPr txBox="1"/>
          <p:nvPr/>
        </p:nvSpPr>
        <p:spPr>
          <a:xfrm>
            <a:off x="252967" y="6588224"/>
            <a:ext cx="582623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phs showing the mean percentage of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(a) or the percentage of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M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 cells (b) in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lenocyte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for 1 h with the MyD88 inhibitor peptide (100 µM), the control peptide (100 µM), resveratrol (50 µM), the same volume of DMSO or media alone and then cultured for 3 days in the absence of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lmonicid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mean+ SD; n= 7).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31649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o 19"/>
          <p:cNvGrpSpPr/>
          <p:nvPr/>
        </p:nvGrpSpPr>
        <p:grpSpPr>
          <a:xfrm>
            <a:off x="620688" y="-180528"/>
            <a:ext cx="3645475" cy="3688413"/>
            <a:chOff x="692696" y="1214621"/>
            <a:chExt cx="3645475" cy="3688413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8720" y="2051720"/>
              <a:ext cx="3015692" cy="2613600"/>
            </a:xfrm>
            <a:prstGeom prst="rect">
              <a:avLst/>
            </a:prstGeom>
          </p:spPr>
        </p:pic>
        <p:grpSp>
          <p:nvGrpSpPr>
            <p:cNvPr id="5" name="Grupo 4"/>
            <p:cNvGrpSpPr/>
            <p:nvPr/>
          </p:nvGrpSpPr>
          <p:grpSpPr>
            <a:xfrm>
              <a:off x="692696" y="1403648"/>
              <a:ext cx="1920080" cy="3485230"/>
              <a:chOff x="233147" y="220104"/>
              <a:chExt cx="1920080" cy="3485230"/>
            </a:xfrm>
          </p:grpSpPr>
          <p:cxnSp>
            <p:nvCxnSpPr>
              <p:cNvPr id="6" name="Conector recto de flecha 5"/>
              <p:cNvCxnSpPr/>
              <p:nvPr/>
            </p:nvCxnSpPr>
            <p:spPr>
              <a:xfrm flipV="1">
                <a:off x="349909" y="1582467"/>
                <a:ext cx="0" cy="200107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CuadroTexto 6"/>
              <p:cNvSpPr txBox="1"/>
              <p:nvPr/>
            </p:nvSpPr>
            <p:spPr>
              <a:xfrm rot="16200000">
                <a:off x="-350324" y="803575"/>
                <a:ext cx="141316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" name="Conector recto de flecha 7"/>
              <p:cNvCxnSpPr/>
              <p:nvPr/>
            </p:nvCxnSpPr>
            <p:spPr>
              <a:xfrm flipV="1">
                <a:off x="350734" y="3582224"/>
                <a:ext cx="868466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CuadroTexto 8"/>
              <p:cNvSpPr txBox="1"/>
              <p:nvPr/>
            </p:nvSpPr>
            <p:spPr>
              <a:xfrm>
                <a:off x="1155700" y="3459113"/>
                <a:ext cx="99752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" name="Grupo 14"/>
            <p:cNvGrpSpPr/>
            <p:nvPr/>
          </p:nvGrpSpPr>
          <p:grpSpPr>
            <a:xfrm>
              <a:off x="2418091" y="1214621"/>
              <a:ext cx="1920080" cy="3688413"/>
              <a:chOff x="233147" y="16921"/>
              <a:chExt cx="1920080" cy="3688413"/>
            </a:xfrm>
          </p:grpSpPr>
          <p:cxnSp>
            <p:nvCxnSpPr>
              <p:cNvPr id="16" name="Conector recto de flecha 15"/>
              <p:cNvCxnSpPr/>
              <p:nvPr/>
            </p:nvCxnSpPr>
            <p:spPr>
              <a:xfrm flipV="1">
                <a:off x="349909" y="1358076"/>
                <a:ext cx="0" cy="2232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CuadroTexto 16"/>
              <p:cNvSpPr txBox="1"/>
              <p:nvPr/>
            </p:nvSpPr>
            <p:spPr>
              <a:xfrm rot="16200000">
                <a:off x="-350324" y="600392"/>
                <a:ext cx="141316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gM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Conector recto de flecha 17"/>
              <p:cNvCxnSpPr/>
              <p:nvPr/>
            </p:nvCxnSpPr>
            <p:spPr>
              <a:xfrm flipV="1">
                <a:off x="350734" y="3582224"/>
                <a:ext cx="868466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CuadroTexto 18"/>
              <p:cNvSpPr txBox="1"/>
              <p:nvPr/>
            </p:nvSpPr>
            <p:spPr>
              <a:xfrm>
                <a:off x="1155700" y="3459113"/>
                <a:ext cx="99752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1" name="59 CuadroTexto"/>
          <p:cNvSpPr txBox="1"/>
          <p:nvPr/>
        </p:nvSpPr>
        <p:spPr>
          <a:xfrm>
            <a:off x="22333" y="8498"/>
            <a:ext cx="6303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smtClean="0"/>
              <a:t>Fig. S4 </a:t>
            </a:r>
            <a:endParaRPr lang="es-ES" sz="1200" b="1" dirty="0"/>
          </a:p>
        </p:txBody>
      </p:sp>
      <p:sp>
        <p:nvSpPr>
          <p:cNvPr id="22" name="CuadroTexto 21"/>
          <p:cNvSpPr txBox="1"/>
          <p:nvPr/>
        </p:nvSpPr>
        <p:spPr>
          <a:xfrm>
            <a:off x="1068658" y="788079"/>
            <a:ext cx="997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efore sorting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1068658" y="2041737"/>
            <a:ext cx="9975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fter sorting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CuadroTexto 23"/>
          <p:cNvSpPr txBox="1"/>
          <p:nvPr/>
        </p:nvSpPr>
        <p:spPr>
          <a:xfrm>
            <a:off x="3392602" y="1633702"/>
            <a:ext cx="9975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8.0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uadroTexto 24"/>
          <p:cNvSpPr txBox="1"/>
          <p:nvPr/>
        </p:nvSpPr>
        <p:spPr>
          <a:xfrm>
            <a:off x="3407003" y="2908376"/>
            <a:ext cx="9975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99.4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ángulo 1"/>
          <p:cNvSpPr/>
          <p:nvPr/>
        </p:nvSpPr>
        <p:spPr>
          <a:xfrm>
            <a:off x="260648" y="3887398"/>
            <a:ext cx="619268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 showing IgM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before (upper panels) and after their sorting (lower panels)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20582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73</TotalTime>
  <Words>576</Words>
  <Application>Microsoft Office PowerPoint</Application>
  <PresentationFormat>Presentación en pantalla (4:3)</PresentationFormat>
  <Paragraphs>152</Paragraphs>
  <Slides>5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olina Tafalla</dc:creator>
  <cp:lastModifiedBy>Carolina</cp:lastModifiedBy>
  <cp:revision>90</cp:revision>
  <dcterms:created xsi:type="dcterms:W3CDTF">2019-10-15T14:56:41Z</dcterms:created>
  <dcterms:modified xsi:type="dcterms:W3CDTF">2020-04-27T10:06:31Z</dcterms:modified>
</cp:coreProperties>
</file>